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83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935228-33A8-B42E-8CAC-80BDB55D95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F8E2263-7EA8-FF10-B166-8B4176705D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36C867-2D48-A1C5-D1CA-6B1F16CA0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2292AA-8144-6208-859E-9ECC9CC9C9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46236F-AFE9-9082-E211-7879DB23D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2202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0CBFD3C-D609-9A1A-1662-0F21E71B46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2909ABF-23AE-558B-2B3D-7AFE6F7CCB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692D5A-1796-44FE-21BB-E9DCC1D5E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40450F-9EFE-D4ED-CBAD-967A2492D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466B79-95DE-80BB-D1C3-6C8BC0C81D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1876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0C60B376-CB0A-72D8-8FEF-F2A914D5E4A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BD338F3-3B7A-8DC6-210C-3BC62A56EE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09A8E0-0323-8774-46A8-E06C2B1552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206298D-9658-9A37-0EC8-F5E63F86D9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D9DD29-0463-B881-E152-2D10944E50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8527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C0C30AF-B660-839C-5E41-C6B612BEA1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B5F84E0-1157-E9A7-6342-6E9D401B65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19248E6-B913-22EB-DAC3-0EDF2CA66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E56140-0C6B-A7B5-B17F-35F848857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AC232A2-81B8-40DF-DAD0-65BAFE725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7341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482329-FA0B-13B7-DB2D-B47C699895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CA0F421-CD4F-7024-3B2B-965384F3EF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24E7895-CB7B-A33D-72E6-5B5F35AF62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4FE37C-FB50-B99A-C72F-6E8630C14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325BC6A-8DCB-C37A-280E-2690F12848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8403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0A6ED08-79A8-AC96-4992-7FFDCB9FF4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47E1178-9413-5B16-B317-AA4C720A9F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54DE251-05FA-ECC3-FBFD-FB16ADDAE2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0BF7482-9457-09F3-28AE-99F427F8E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C02231C-F063-A3AC-E077-0896FDDB3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20A498-093D-BB4D-3003-2D5C6ECB6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464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41E7DA3-B4BB-FE99-8FA8-D559365DDF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374C3A5-CBEA-1175-2BE9-CFF6B1E016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7E8A206-4DF1-ED9F-62E3-3E4A8CE38A9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EFA6422-B82C-FDB0-C306-7181DC6F98B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9DE664D-2EEF-B854-AF11-DA0C24907E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B93DDAB-AB32-81DD-A924-933D52E79A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30B974F-65D9-0CE1-E852-4AC8E8A34B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1232EAA-F41A-4E70-902A-ACC827895A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0927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C37C76-0B78-EB23-0210-6124F7F8FE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788DF7C1-9BD9-69FB-178F-5C70FEFB00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AD5630FA-F89C-1ABD-559E-B136BD9CC5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54F307C-8688-9543-4E72-A58187B4B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2238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9E68A0A-5A04-E616-22B9-F87204273F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47977AB-5B3A-50A1-5A70-E7EE4124D7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7E03970-7E41-D2AC-E5F4-946D70E86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8799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0A845BB-6D66-D0DE-B939-BC153E0DFD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1EB233-E716-A187-4F2A-4F7806D0A9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BE8806C-F963-7DA7-895B-F2119864B8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EB2C6E3-556D-8268-8BC2-68573C525F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3C45F4-1AC7-D0CD-8E8E-B7AC900D9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3A1D364-EF04-7FAD-F5B4-40E453BE9C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425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F0B8BF-4A63-24D4-E263-70316CF246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6B2451F-274E-6BA3-DC45-DA1C166807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5078504-E2DB-404F-A9F8-323D9DD426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4A76836-D1C6-1FEA-AF52-DA6A11DE1B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6B8C34F-CCE6-7191-AD43-6BB662BFC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12F6A2-A9D5-C6F4-AAE8-CBFA0F0830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498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76585C8E-6F89-7EB3-74C1-BA7ADE5001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B7BD87D-2EF1-9BE0-BD42-016ED48882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ECBEB2-A67E-EDAC-69F8-2C85D1DFDF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138305-75ED-4B1D-905E-42B72A7B22D9}" type="datetimeFigureOut">
              <a:rPr kumimoji="1" lang="ja-JP" altLang="en-US" smtClean="0"/>
              <a:t>2024/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11B3C13-E7C4-9F1A-349C-09E20E5F28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544940-9392-6546-2C8E-D37A63A529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3F479-7B63-4242-82A3-123F099C474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228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>
            <a:extLst>
              <a:ext uri="{FF2B5EF4-FFF2-40B4-BE49-F238E27FC236}">
                <a16:creationId xmlns:a16="http://schemas.microsoft.com/office/drawing/2014/main" id="{A3652E83-EA09-4B86-A15D-4C67A2FD25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35585" y="1210725"/>
            <a:ext cx="5731536" cy="4624467"/>
          </a:xfrm>
          <a:prstGeom prst="rect">
            <a:avLst/>
          </a:prstGeom>
        </p:spPr>
      </p:pic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A4740CAF-AAF2-4913-A743-8D5BB61A1A01}"/>
              </a:ext>
            </a:extLst>
          </p:cNvPr>
          <p:cNvSpPr txBox="1"/>
          <p:nvPr/>
        </p:nvSpPr>
        <p:spPr>
          <a:xfrm>
            <a:off x="1521039" y="851471"/>
            <a:ext cx="5713018" cy="20928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ea typeface="Meiryo UI" panose="020B0604030504040204" pitchFamily="50" charset="-128"/>
              </a:rPr>
              <a:t>Each regional block include following prefectures.</a:t>
            </a:r>
          </a:p>
          <a:p>
            <a:r>
              <a:rPr lang="en-US" altLang="ja-JP" sz="1000" dirty="0"/>
              <a:t> - Hokkaido: 1 Hokkaido.</a:t>
            </a:r>
          </a:p>
          <a:p>
            <a:r>
              <a:rPr lang="en-US" altLang="ja-JP" sz="1000" dirty="0"/>
              <a:t> - Tohoku: 2 Aomori, 3 Iwate, 4 Miyagi, 5 Akita, 6 Yamagata and 7 Fukushima.</a:t>
            </a:r>
          </a:p>
          <a:p>
            <a:r>
              <a:rPr lang="en-US" altLang="ja-JP" sz="1000" dirty="0"/>
              <a:t> - Kanto I: 8 Saitama, 9 Chiba, 10 Tokyo and 11 Kanagawa.</a:t>
            </a:r>
          </a:p>
          <a:p>
            <a:r>
              <a:rPr lang="en-US" altLang="ja-JP" sz="1000" dirty="0"/>
              <a:t> - Kanto </a:t>
            </a:r>
            <a:r>
              <a:rPr lang="en-US" altLang="ja-JP" sz="1000" dirty="0">
                <a:effectLst/>
                <a:ea typeface="Meiryo UI" panose="020B0604030504040204" pitchFamily="50" charset="-128"/>
              </a:rPr>
              <a:t>II</a:t>
            </a:r>
            <a:r>
              <a:rPr lang="en-US" altLang="ja-JP" sz="1000" dirty="0"/>
              <a:t>: 12 Ibaraki, 13 Tochigi, 14 Gunma, 15 Yamanashi and 16 Nagano.</a:t>
            </a:r>
          </a:p>
          <a:p>
            <a:r>
              <a:rPr lang="en-US" altLang="ja-JP" sz="1000" dirty="0"/>
              <a:t> - Hokuriku: 17 Niigata, 18 Toyama, 19 Ishikawa and 20 Fukui.</a:t>
            </a:r>
          </a:p>
          <a:p>
            <a:r>
              <a:rPr lang="en-US" altLang="ja-JP" sz="1000" dirty="0"/>
              <a:t> - Tokai: 21 Gifu, 22 Aichi, 23 Mie and 24 Shizuoka.</a:t>
            </a:r>
          </a:p>
          <a:p>
            <a:r>
              <a:rPr lang="en-US" altLang="ja-JP" sz="1000" dirty="0"/>
              <a:t> - Kinki I: 25 Kyoto, 26 Osaka and 27 Hyogo.</a:t>
            </a:r>
          </a:p>
          <a:p>
            <a:r>
              <a:rPr lang="en-US" altLang="ja-JP" sz="1000" dirty="0"/>
              <a:t> - Kinki II: 28</a:t>
            </a:r>
            <a:r>
              <a:rPr lang="ja-JP" altLang="en-US" sz="1000" dirty="0"/>
              <a:t> </a:t>
            </a:r>
            <a:r>
              <a:rPr lang="en-US" altLang="ja-JP" sz="1000" dirty="0"/>
              <a:t>Nara, 29 Wakayama and 30 Shiga.</a:t>
            </a:r>
          </a:p>
          <a:p>
            <a:r>
              <a:rPr lang="en-US" altLang="ja-JP" sz="1000" dirty="0"/>
              <a:t> - Chugoku: 31 Tottori, 32 Shimane, 33 Okayama, 34 Hiroshima and 35 Yamaguchi.</a:t>
            </a:r>
          </a:p>
          <a:p>
            <a:r>
              <a:rPr lang="en-US" altLang="ja-JP" sz="1000" dirty="0"/>
              <a:t> - Shikoku: 36 Tokushima, 37 Kagawa, 38 Ehime and 39 Kochi.</a:t>
            </a:r>
          </a:p>
          <a:p>
            <a:r>
              <a:rPr lang="en-US" altLang="ja-JP" sz="1000" dirty="0"/>
              <a:t> - Kita Kyushu: 40 Fukuoka, 41 Saga, 42 Nagasaki and 43 Oita.</a:t>
            </a:r>
          </a:p>
          <a:p>
            <a:r>
              <a:rPr lang="en-US" altLang="ja-JP" sz="1000" dirty="0"/>
              <a:t> - Minami Kyusyu: 44 Kumamoto, 45 Miyazaki, 46 Kagoshima and 47 Okinawa.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2E2F50E-D3C0-2F0D-2D61-DBDB2F5B049A}"/>
              </a:ext>
            </a:extLst>
          </p:cNvPr>
          <p:cNvSpPr txBox="1"/>
          <p:nvPr/>
        </p:nvSpPr>
        <p:spPr>
          <a:xfrm>
            <a:off x="928952" y="91268"/>
            <a:ext cx="95750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dirty="0"/>
              <a:t>S1 Fig. Map of Regional blocks and prefectures in Japan.</a:t>
            </a:r>
            <a:endParaRPr kumimoji="1" lang="ja-JP" altLang="en-US" sz="2800" dirty="0"/>
          </a:p>
        </p:txBody>
      </p:sp>
    </p:spTree>
    <p:extLst>
      <p:ext uri="{BB962C8B-B14F-4D97-AF65-F5344CB8AC3E}">
        <p14:creationId xmlns:p14="http://schemas.microsoft.com/office/powerpoint/2010/main" val="1932454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214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 UI</vt:lpstr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逸見治</dc:creator>
  <cp:lastModifiedBy>横山徹爾</cp:lastModifiedBy>
  <cp:revision>26</cp:revision>
  <dcterms:created xsi:type="dcterms:W3CDTF">2023-07-05T01:10:53Z</dcterms:created>
  <dcterms:modified xsi:type="dcterms:W3CDTF">2024-01-19T09:17:55Z</dcterms:modified>
</cp:coreProperties>
</file>